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3"/>
  </p:notesMasterIdLst>
  <p:sldIdLst>
    <p:sldId id="256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70" r:id="rId1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3"/>
    <p:restoredTop sz="94643"/>
  </p:normalViewPr>
  <p:slideViewPr>
    <p:cSldViewPr snapToGrid="0">
      <p:cViewPr varScale="1">
        <p:scale>
          <a:sx n="143" d="100"/>
          <a:sy n="143" d="100"/>
        </p:scale>
        <p:origin x="200" y="24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g5134a6e3a2_0_8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9" name="Google Shape;129;g5134a6e3a2_0_8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9. Feature classification summary across Boruta bootstraps (N = 1,000) with </a:t>
            </a:r>
            <a:r>
              <a:rPr lang="en-US" sz="1100" b="0" i="0" u="none" strike="noStrike" cap="none" dirty="0" err="1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XGBoost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 importance. 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g5134a6e3a2_0_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5" name="Google Shape;135;g5134a6e3a2_0_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dirty="0"/>
              <a:t>10. Recurrent important gene features from Boruta bootstraps with 5 importance metrics, showing genes confirmed in 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1/1,000 bootstraps (A), or at least 5% or 50/1,000 bootstraps (B).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g5134a6e3a2_0_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1" name="Google Shape;81;g5134a6e3a2_0_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1. Correlation of gene expression (entire dataset) across gene features selected in iteration 1 vs. iterations 2-4 of </a:t>
            </a:r>
            <a:r>
              <a:rPr lang="en-US" dirty="0" err="1"/>
              <a:t>XGBoost</a:t>
            </a:r>
            <a:r>
              <a:rPr lang="en-US" dirty="0"/>
              <a:t> ablation tests (see Results, Supplemental Materials).</a:t>
            </a: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g5134a6e3a2_0_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7" name="Google Shape;87;g5134a6e3a2_0_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2. </a:t>
            </a:r>
            <a:r>
              <a:rPr lang="en-US" dirty="0" err="1"/>
              <a:t>XGBoost</a:t>
            </a:r>
            <a:r>
              <a:rPr lang="en-US" dirty="0"/>
              <a:t> fitted model performances across 70 iterations of ablation. (Top) true positive rate (TPR), and true negative rate (TNR). (Bottom) false discovery rate (FDR) and false omission rate (FOR). </a:t>
            </a: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5134a6e3a2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3" name="Google Shape;93;g5134a6e3a2_0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3. Boruta permutations consensus rank metric comparison. Comparison of naive (x-axis) and normalized (y-axis) rank across features, for each of 4 algorithms used (see Figure 4A, Supplemental Materials).</a:t>
            </a:r>
            <a:endParaRPr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g5134a6e3a2_0_5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9" name="Google Shape;99;g5134a6e3a2_0_5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4. Comparison of feature importance across Boruta permutations for 5 bootstrap iterations (selected at random). Each column shows bootstraps for </a:t>
            </a:r>
            <a:r>
              <a:rPr lang="en-US" dirty="0" err="1"/>
              <a:t>premutations</a:t>
            </a:r>
            <a:r>
              <a:rPr lang="en-US" dirty="0"/>
              <a:t> with a different importance metric (either lasso, consensus importance “</a:t>
            </a:r>
            <a:r>
              <a:rPr lang="en-US" dirty="0" err="1"/>
              <a:t>nrank</a:t>
            </a:r>
            <a:r>
              <a:rPr lang="en-US" dirty="0"/>
              <a:t>”, random forest “</a:t>
            </a:r>
            <a:r>
              <a:rPr lang="en-US" dirty="0" err="1"/>
              <a:t>rf</a:t>
            </a:r>
            <a:r>
              <a:rPr lang="en-US" dirty="0"/>
              <a:t>”, SVM “</a:t>
            </a:r>
            <a:r>
              <a:rPr lang="en-US" dirty="0" err="1"/>
              <a:t>svm</a:t>
            </a:r>
            <a:r>
              <a:rPr lang="en-US" dirty="0"/>
              <a:t>”, or </a:t>
            </a:r>
            <a:r>
              <a:rPr lang="en-US" dirty="0" err="1"/>
              <a:t>XGBoost</a:t>
            </a:r>
            <a:r>
              <a:rPr lang="en-US" dirty="0"/>
              <a:t> “</a:t>
            </a:r>
            <a:r>
              <a:rPr lang="en-US" dirty="0" err="1"/>
              <a:t>xgb</a:t>
            </a:r>
            <a:r>
              <a:rPr lang="en-US" dirty="0"/>
              <a:t>”).</a:t>
            </a: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g5134a6e3a2_0_5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5" name="Google Shape;105;g5134a6e3a2_0_5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5. Feature classification summary across Boruta bootstraps (N = 1,000) with consensus importance (“</a:t>
            </a:r>
            <a:r>
              <a:rPr lang="en-US" sz="1100" b="0" i="0" u="none" strike="noStrike" cap="none" dirty="0" err="1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nrank</a:t>
            </a: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”). 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g5134a6e3a2_0_6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1" name="Google Shape;111;g5134a6e3a2_0_6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6. Feature classification summary across Boruta bootstraps (N = 1,000) with Random Forest importance. 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g5134a6e3a2_0_7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7" name="Google Shape;117;g5134a6e3a2_0_7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7. Feature classification summary across Boruta bootstraps (N = 1,000) with lasso importance. 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Google Shape;122;g5134a6e3a2_0_7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3" name="Google Shape;123;g5134a6e3a2_0_7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sz="1100" b="0" i="0" u="none" strike="noStrike" cap="none" dirty="0">
                <a:solidFill>
                  <a:srgbClr val="000000"/>
                </a:solidFill>
                <a:effectLst/>
                <a:latin typeface="Arial"/>
                <a:ea typeface="Arial"/>
                <a:cs typeface="Arial"/>
                <a:sym typeface="Arial"/>
              </a:rPr>
              <a:t>8. Feature classification summary across Boruta bootstraps (N = 1,000) with SVM importance. </a:t>
            </a: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Supplemental Figures</a:t>
            </a:r>
            <a:endParaRPr/>
          </a:p>
        </p:txBody>
      </p:sp>
      <p:sp>
        <p:nvSpPr>
          <p:cNvPr id="55" name="Google Shape;55;p13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/>
            <a:r>
              <a:rPr lang="en-US" dirty="0"/>
              <a:t>Consensus Machine Learning for Gene Target Selection in Pediatric AML Risk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Google Shape;131;p2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967025" y="152400"/>
            <a:ext cx="4838704" cy="483870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Google Shape;138;p2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813975" y="913399"/>
            <a:ext cx="4330025" cy="30928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9" name="Google Shape;139;p27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0" y="913399"/>
            <a:ext cx="4330040" cy="3092875"/>
          </a:xfrm>
          <a:prstGeom prst="rect">
            <a:avLst/>
          </a:prstGeom>
          <a:noFill/>
          <a:ln>
            <a:noFill/>
          </a:ln>
        </p:spPr>
      </p:pic>
      <p:sp>
        <p:nvSpPr>
          <p:cNvPr id="140" name="Google Shape;140;p27"/>
          <p:cNvSpPr txBox="1"/>
          <p:nvPr/>
        </p:nvSpPr>
        <p:spPr>
          <a:xfrm>
            <a:off x="0" y="729298"/>
            <a:ext cx="638100" cy="57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500" b="1" dirty="0"/>
              <a:t>A</a:t>
            </a:r>
            <a:endParaRPr sz="2500" b="1" dirty="0"/>
          </a:p>
        </p:txBody>
      </p:sp>
      <p:sp>
        <p:nvSpPr>
          <p:cNvPr id="141" name="Google Shape;141;p27"/>
          <p:cNvSpPr txBox="1"/>
          <p:nvPr/>
        </p:nvSpPr>
        <p:spPr>
          <a:xfrm>
            <a:off x="4813975" y="729298"/>
            <a:ext cx="638100" cy="57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2500" b="1" dirty="0"/>
              <a:t>B</a:t>
            </a:r>
            <a:endParaRPr sz="25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8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50875" y="333069"/>
            <a:ext cx="8258325" cy="440447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Google Shape;89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886635" y="0"/>
            <a:ext cx="3191436" cy="510629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Google Shape;96;p2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199250" y="655175"/>
            <a:ext cx="4347900" cy="43479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2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918447" y="0"/>
            <a:ext cx="4967732" cy="4967732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Google Shape;107;p22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03875" y="152400"/>
            <a:ext cx="4838704" cy="483870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Google Shape;113;p2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79625" y="352475"/>
            <a:ext cx="4716048" cy="471604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Google Shape;119;p2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954500" y="152400"/>
            <a:ext cx="4838704" cy="483870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Google Shape;125;p2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29575" y="152400"/>
            <a:ext cx="4838704" cy="483870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303</Words>
  <Application>Microsoft Macintosh PowerPoint</Application>
  <PresentationFormat>On-screen Show (16:9)</PresentationFormat>
  <Paragraphs>14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3" baseType="lpstr">
      <vt:lpstr>Arial</vt:lpstr>
      <vt:lpstr>Simple Light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cp:lastModifiedBy>Microsoft Office User</cp:lastModifiedBy>
  <cp:revision>25</cp:revision>
  <dcterms:modified xsi:type="dcterms:W3CDTF">2019-05-05T03:53:48Z</dcterms:modified>
</cp:coreProperties>
</file>